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3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126" y="6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Galectin-3%20in%20CNV\Real-time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Results!$D$94:$F$94</c:f>
                <c:numCache>
                  <c:formatCode>General</c:formatCode>
                  <c:ptCount val="3"/>
                  <c:pt idx="0">
                    <c:v>7.6441179971323728E-2</c:v>
                  </c:pt>
                  <c:pt idx="1">
                    <c:v>0.1438661521851381</c:v>
                  </c:pt>
                  <c:pt idx="2">
                    <c:v>7.0611955915322058E-2</c:v>
                  </c:pt>
                </c:numCache>
              </c:numRef>
            </c:plus>
            <c:minus>
              <c:numRef>
                <c:f>Results!$D$94:$F$94</c:f>
                <c:numCache>
                  <c:formatCode>General</c:formatCode>
                  <c:ptCount val="3"/>
                  <c:pt idx="0">
                    <c:v>7.6441179971323728E-2</c:v>
                  </c:pt>
                  <c:pt idx="1">
                    <c:v>0.1438661521851381</c:v>
                  </c:pt>
                  <c:pt idx="2">
                    <c:v>7.0611955915322058E-2</c:v>
                  </c:pt>
                </c:numCache>
              </c:numRef>
            </c:minus>
            <c:spPr>
              <a:ln>
                <a:solidFill>
                  <a:schemeClr val="tx1"/>
                </a:solidFill>
              </a:ln>
            </c:spPr>
          </c:errBars>
          <c:cat>
            <c:strRef>
              <c:f>Results!$D$81:$F$81</c:f>
              <c:strCache>
                <c:ptCount val="3"/>
                <c:pt idx="0">
                  <c:v>ARPE-19</c:v>
                </c:pt>
                <c:pt idx="1">
                  <c:v>CON-siRNA</c:v>
                </c:pt>
                <c:pt idx="2">
                  <c:v>Lgals-3 siRNA</c:v>
                </c:pt>
              </c:strCache>
            </c:strRef>
          </c:cat>
          <c:val>
            <c:numRef>
              <c:f>Results!$D$96:$F$96</c:f>
              <c:numCache>
                <c:formatCode>General</c:formatCode>
                <c:ptCount val="3"/>
                <c:pt idx="0">
                  <c:v>1</c:v>
                </c:pt>
                <c:pt idx="1">
                  <c:v>0.97338462117344549</c:v>
                </c:pt>
                <c:pt idx="2">
                  <c:v>3.175146263854253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4FB-4C2E-AFC1-D072CA1D930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1"/>
        <c:overlap val="-27"/>
        <c:axId val="35275296"/>
        <c:axId val="1"/>
      </c:barChart>
      <c:catAx>
        <c:axId val="352752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  <c:max val="1.5"/>
          <c:min val="0"/>
        </c:scaling>
        <c:delete val="0"/>
        <c:axPos val="l"/>
        <c:numFmt formatCode="General" sourceLinked="1"/>
        <c:majorTickMark val="out"/>
        <c:minorTickMark val="none"/>
        <c:tickLblPos val="none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35275296"/>
        <c:crosses val="autoZero"/>
        <c:crossBetween val="between"/>
        <c:majorUnit val="0.5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/>
      </a:pPr>
      <a:endParaRPr lang="zh-CN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647B6-A943-4D8E-8664-5E41E5056113}" type="datetimeFigureOut">
              <a:rPr lang="zh-CN" altLang="en-US" smtClean="0"/>
              <a:t>2024/10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05B34-3925-4742-92C3-AA80382D46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01335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647B6-A943-4D8E-8664-5E41E5056113}" type="datetimeFigureOut">
              <a:rPr lang="zh-CN" altLang="en-US" smtClean="0"/>
              <a:t>2024/10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05B34-3925-4742-92C3-AA80382D46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79107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647B6-A943-4D8E-8664-5E41E5056113}" type="datetimeFigureOut">
              <a:rPr lang="zh-CN" altLang="en-US" smtClean="0"/>
              <a:t>2024/10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05B34-3925-4742-92C3-AA80382D46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915241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647B6-A943-4D8E-8664-5E41E5056113}" type="datetimeFigureOut">
              <a:rPr lang="zh-CN" altLang="en-US" smtClean="0"/>
              <a:t>2024/10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05B34-3925-4742-92C3-AA80382D46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50054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647B6-A943-4D8E-8664-5E41E5056113}" type="datetimeFigureOut">
              <a:rPr lang="zh-CN" altLang="en-US" smtClean="0"/>
              <a:t>2024/10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05B34-3925-4742-92C3-AA80382D46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34840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647B6-A943-4D8E-8664-5E41E5056113}" type="datetimeFigureOut">
              <a:rPr lang="zh-CN" altLang="en-US" smtClean="0"/>
              <a:t>2024/10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05B34-3925-4742-92C3-AA80382D46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38779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647B6-A943-4D8E-8664-5E41E5056113}" type="datetimeFigureOut">
              <a:rPr lang="zh-CN" altLang="en-US" smtClean="0"/>
              <a:t>2024/10/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05B34-3925-4742-92C3-AA80382D46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25002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647B6-A943-4D8E-8664-5E41E5056113}" type="datetimeFigureOut">
              <a:rPr lang="zh-CN" altLang="en-US" smtClean="0"/>
              <a:t>2024/10/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05B34-3925-4742-92C3-AA80382D46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6520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647B6-A943-4D8E-8664-5E41E5056113}" type="datetimeFigureOut">
              <a:rPr lang="zh-CN" altLang="en-US" smtClean="0"/>
              <a:t>2024/10/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05B34-3925-4742-92C3-AA80382D46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33963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647B6-A943-4D8E-8664-5E41E5056113}" type="datetimeFigureOut">
              <a:rPr lang="zh-CN" altLang="en-US" smtClean="0"/>
              <a:t>2024/10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05B34-3925-4742-92C3-AA80382D46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7373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A647B6-A943-4D8E-8664-5E41E5056113}" type="datetimeFigureOut">
              <a:rPr lang="zh-CN" altLang="en-US" smtClean="0"/>
              <a:t>2024/10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05B34-3925-4742-92C3-AA80382D46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20897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A647B6-A943-4D8E-8664-5E41E5056113}" type="datetimeFigureOut">
              <a:rPr lang="zh-CN" altLang="en-US" smtClean="0"/>
              <a:t>2024/10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D05B34-3925-4742-92C3-AA80382D46C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18624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57835184"/>
              </p:ext>
            </p:extLst>
          </p:nvPr>
        </p:nvGraphicFramePr>
        <p:xfrm>
          <a:off x="2238375" y="1674105"/>
          <a:ext cx="28944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文本框 4"/>
          <p:cNvSpPr txBox="1"/>
          <p:nvPr/>
        </p:nvSpPr>
        <p:spPr>
          <a:xfrm>
            <a:off x="1842466" y="1560095"/>
            <a:ext cx="213200" cy="287258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8255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zh-CN" sz="1200" b="1" i="0" u="none" strike="noStrike" cap="none" spc="0" normalizeH="0" baseline="0" dirty="0" smtClean="0">
                <a:ln>
                  <a:noFill/>
                </a:ln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Helvetica Neue"/>
              </a:rPr>
              <a:t>A</a:t>
            </a:r>
            <a:endParaRPr kumimoji="0" lang="zh-CN" altLang="en-US" sz="1200" b="1" i="0" u="none" strike="noStrike" cap="none" spc="0" normalizeH="0" baseline="0" dirty="0">
              <a:ln>
                <a:noFill/>
              </a:ln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Helvetica Neue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2140738" y="414146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2038085" y="3323422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2034940" y="2505381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2034940" y="1687340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2493573" y="4294194"/>
            <a:ext cx="5982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ormal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3221575" y="4291453"/>
            <a:ext cx="8258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on-siRN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4098417" y="4291454"/>
            <a:ext cx="10343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Lgals3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 siRNA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4422554" y="3922123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407984" y="4744331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3063563" y="1933561"/>
            <a:ext cx="14943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ALECTIN-3/</a:t>
            </a:r>
            <a:r>
              <a:rPr lang="en-US" altLang="zh-CN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LGALS3</a:t>
            </a:r>
            <a:endParaRPr lang="zh-CN" alt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Cell viability (Arbitrary units)"/>
          <p:cNvSpPr txBox="1"/>
          <p:nvPr/>
        </p:nvSpPr>
        <p:spPr>
          <a:xfrm rot="16200000">
            <a:off x="700374" y="2866725"/>
            <a:ext cx="2615253" cy="25648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square" lIns="50800" tIns="50800" rIns="50800" bIns="50800" anchor="ctr">
            <a:spAutoFit/>
          </a:bodyPr>
          <a:lstStyle>
            <a:lvl1pPr>
              <a:defRPr sz="2000" b="0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en-US" sz="1000" dirty="0" smtClean="0"/>
              <a:t>Relative Gene Expression of G</a:t>
            </a:r>
            <a:r>
              <a:rPr lang="en-US" altLang="zh-CN" sz="1000" dirty="0" smtClean="0"/>
              <a:t>ALECTIN</a:t>
            </a:r>
            <a:r>
              <a:rPr lang="en-US" sz="1000" dirty="0" smtClean="0"/>
              <a:t>-3</a:t>
            </a:r>
            <a:endParaRPr sz="1000" dirty="0"/>
          </a:p>
        </p:txBody>
      </p:sp>
    </p:spTree>
    <p:extLst>
      <p:ext uri="{BB962C8B-B14F-4D97-AF65-F5344CB8AC3E}">
        <p14:creationId xmlns:p14="http://schemas.microsoft.com/office/powerpoint/2010/main" val="11649527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1139528" y="744191"/>
            <a:ext cx="10488816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/>
              <a:t>GAAGTTACTCAATGATATCTTAATTGATTTTATTGGGTTCCTTTTTACGCTTATCTTAGAAAAGGGATGTGACTTTGGATTGGGTAATAAAGAGCCGTTTATTGCATGTGTACAAATTATAAATTCCCAGGCACACCCTGATCATAGCAGGATCCTTTTGTTAGCTTTATGGGGCATGAAGTTGGCACCAAAGTATTCATGGGGATGTACAAGTAAGGAAGGGAAGCCAAAAGCATGTCTGATCATACAATCAGGTGTAAGCAAGCCCCCTAAGTAGCCAGGGCATGAACTTTGTCTATCTCTGAAATGACCAGAAGAAAAGGCAAGAGTGTGATTCATCCCTTGCCTCCACAGCAATTCATTTGGCTATCTACTTTTCTTATTACCAATGGCTAACCCTCTAAGGGTACCACTCCTGGCCATGAGGCCTCATGACTCAAAGTCTTAAGATTTATAGCATTTTCCCTGGAGACCAAGGGCATTCCTTTGGGTGATACCTTTTTACTACCCAGAGGTTAGTCATTTACTATGGGTGATCCATTCAAATAAATTGGTTGCCAGGCTACCTCTTCAGATAAGAGTTCAAACTTGCATAAATAATCCCCAGCCACACTGTGACTTCTATGTGCAAGCCTAGAGGGGACGATGTTGCAGGAA</a:t>
            </a:r>
            <a:r>
              <a:rPr lang="en-US" altLang="zh-CN" sz="1200" b="1" dirty="0" smtClean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CCGTG</a:t>
            </a:r>
            <a:r>
              <a:rPr lang="en-US" altLang="zh-CN" sz="1200" b="1" dirty="0" smtClean="0"/>
              <a:t>CCAACCACTAAGACACTTTCAAGTTTATCCTAGAGAATGCCAAGACAGCTTCTCAATTCCATCAAGTGAGTCCTTCACAGGAACATTTCCCTAAGTTGAAAAACTGCAGGAAATAATTTATCTTTATGTTATTAATTGGTTACTATAAGGGCTACAGGAATTATTTAGGAACCAGATGATACCTGGTTTTCTCCATAGTTTACATAAGCCAGTCCCTGCAAAGATTCTTCCCCTACCCCCCTTAATTTTTTTTTTTTTCCTCAGAGATCCTTGTTCCAACCTGCAAGGATTCTTTGGCCTGGTGCTTTTCCAGGTAAAGTGTAAGAGCCAGGATTTCTGGATTTTGTTCCTAGACATGAGTGAGCTTGGATAAGTAAATCATTTTCTCTTTTAGTCTGTTTGGGCTTCTGTAACAAAATATCATAAACTGGGTAGCTTATAGGCAATATACATTTATTTCCCACAGTTCTGAAGGTCGGGAAATCCAAGATCCAGGCCAGCAGATTTGATGTCTGGTGAGGGCCTGCTTTCTGGTTCACAGAGGGAGCCTTCTGGCTGTGTCTTCACAAGGTGGAAGTGGCAAGGGGTCTCTCTCCGGCCTCTTTTATTAGGGCACCAATCTCATTCATAAGGACCCTGCCCCTATGACCTAATCACTTCCCAAGGCCTCCACTTCCTAATACATCA</a:t>
            </a:r>
            <a:r>
              <a:rPr lang="en-US" altLang="zh-CN" sz="1200" b="1" dirty="0" smtClean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CCGTG</a:t>
            </a:r>
            <a:r>
              <a:rPr lang="en-US" altLang="zh-CN" sz="1200" b="1" dirty="0" smtClean="0"/>
              <a:t>AGGGTTAGGATTTCAACATATGAACTTTGGCGGGATATAAACATTCAGACTATAGCACCCTGACAGTAAAAATGAGATAATAATACTTATCTCTTTCTTCCAACAAAAAGATAAGGTGAAGTTAAAAGGAGGGTATATATATATATAATGTGAATTTCCTGTGTAAAATGTGTTAAAGAGTTGTCTGATTAATTGCTTTATAAGGGAATTGCTTTGAGACTAGGCCTATTGATCTAGAATAAGTAGTCAATTTGTAGTCAGTTCCCTAGGGAATAGACATTGAAAAGATTTTTGGTTTTGTATTCTACAAATAAAGCAACCTATTAATTGAATTCCTCTCAGCGAATTCTTCACTCAGGTGATTCTGGAGAGGGCGGGGGACAGACGCGGCCGCAGCCCAGGTCCCGGGAGCGC</a:t>
            </a:r>
            <a:r>
              <a:rPr lang="en-US" altLang="zh-CN" sz="1200" b="1" dirty="0" smtClean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CACGG</a:t>
            </a:r>
            <a:r>
              <a:rPr lang="en-US" altLang="zh-CN" sz="1200" b="1" dirty="0" smtClean="0"/>
              <a:t>AACCTAACGGTGGCAGCGGAGGTCGCGCCCCTCAGTGCCCGCGCTCTCCCCGTCGGGAGCTTCCTGGTCGCCCCTGCGGCGGCGGCTCGGGGTGTCTGGCCGGCGCGGGGCTCGCCCAGCCTGGTCCGGGGAGAGGACTGGCTGGGCAGGGGCGCCGCCCCGCCTCGGGAGAGGCGGGCCGGGCGGGGCTGGGAGTATTTGAGGCTCGGAGCCACCGCCCCGCCGGCGCCCGCAGCACCTCCTCGCCAGCAGCCGTCCGGAGCCAGCCAACGAGCGGTGAGCTGCGCGGGGCGCGGGGGACGCGGCTCCGGCCGGGCAGGGGAGAGG</a:t>
            </a:r>
            <a:endParaRPr lang="zh-CN" altLang="zh-CN" sz="1200" b="1" dirty="0"/>
          </a:p>
          <a:p>
            <a:endParaRPr lang="zh-CN" altLang="en-US" sz="1200" b="1" dirty="0"/>
          </a:p>
        </p:txBody>
      </p:sp>
      <p:sp>
        <p:nvSpPr>
          <p:cNvPr id="3" name="文本框 2"/>
          <p:cNvSpPr txBox="1"/>
          <p:nvPr/>
        </p:nvSpPr>
        <p:spPr>
          <a:xfrm>
            <a:off x="658637" y="528748"/>
            <a:ext cx="213200" cy="287258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8255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zh-CN" sz="1200" b="1" i="0" u="none" strike="noStrike" cap="none" spc="0" normalizeH="0" baseline="0" dirty="0" smtClean="0">
                <a:ln>
                  <a:noFill/>
                </a:ln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Helvetica Neue"/>
              </a:rPr>
              <a:t>A</a:t>
            </a:r>
            <a:endParaRPr kumimoji="0" lang="zh-CN" altLang="en-US" sz="1200" b="1" i="0" u="none" strike="noStrike" cap="none" spc="0" normalizeH="0" baseline="0" dirty="0">
              <a:ln>
                <a:noFill/>
              </a:ln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Helvetica Neue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407984" y="4858138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604145" y="744191"/>
            <a:ext cx="6014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/>
              <a:t>-2000</a:t>
            </a:r>
            <a:endParaRPr lang="zh-CN" altLang="en-US" sz="1200" b="1" dirty="0"/>
          </a:p>
        </p:txBody>
      </p:sp>
      <p:sp>
        <p:nvSpPr>
          <p:cNvPr id="6" name="文本框 5"/>
          <p:cNvSpPr txBox="1"/>
          <p:nvPr/>
        </p:nvSpPr>
        <p:spPr>
          <a:xfrm>
            <a:off x="673875" y="4204567"/>
            <a:ext cx="4619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/>
              <a:t>+99</a:t>
            </a:r>
            <a:endParaRPr lang="zh-CN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6572120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</TotalTime>
  <Words>28</Words>
  <Application>Microsoft Office PowerPoint</Application>
  <PresentationFormat>宽屏</PresentationFormat>
  <Paragraphs>17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Helvetica Neue</vt:lpstr>
      <vt:lpstr>等线</vt:lpstr>
      <vt:lpstr>等线 Light</vt:lpstr>
      <vt:lpstr>Arial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</dc:creator>
  <cp:lastModifiedBy>admin</cp:lastModifiedBy>
  <cp:revision>9</cp:revision>
  <dcterms:created xsi:type="dcterms:W3CDTF">2024-07-15T07:49:44Z</dcterms:created>
  <dcterms:modified xsi:type="dcterms:W3CDTF">2024-10-07T08:27:25Z</dcterms:modified>
</cp:coreProperties>
</file>